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8974" autoAdjust="0"/>
  </p:normalViewPr>
  <p:slideViewPr>
    <p:cSldViewPr>
      <p:cViewPr>
        <p:scale>
          <a:sx n="140" d="100"/>
          <a:sy n="140" d="100"/>
        </p:scale>
        <p:origin x="-84" y="1872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FF745F-B3EC-471C-8350-051F954AFA97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0CA16-1179-4101-BD36-80C39AD70DA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FF745F-B3EC-471C-8350-051F954AFA97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0CA16-1179-4101-BD36-80C39AD70DA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FF745F-B3EC-471C-8350-051F954AFA97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0CA16-1179-4101-BD36-80C39AD70DA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FF745F-B3EC-471C-8350-051F954AFA97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0CA16-1179-4101-BD36-80C39AD70DA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FF745F-B3EC-471C-8350-051F954AFA97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0CA16-1179-4101-BD36-80C39AD70DA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FF745F-B3EC-471C-8350-051F954AFA97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0CA16-1179-4101-BD36-80C39AD70DA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FF745F-B3EC-471C-8350-051F954AFA97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0CA16-1179-4101-BD36-80C39AD70DA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FF745F-B3EC-471C-8350-051F954AFA97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0CA16-1179-4101-BD36-80C39AD70DA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FF745F-B3EC-471C-8350-051F954AFA97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0CA16-1179-4101-BD36-80C39AD70DA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FF745F-B3EC-471C-8350-051F954AFA97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0CA16-1179-4101-BD36-80C39AD70DA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FF745F-B3EC-471C-8350-051F954AFA97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20CA16-1179-4101-BD36-80C39AD70DA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FF745F-B3EC-471C-8350-051F954AFA97}" type="datetimeFigureOut">
              <a:rPr lang="zh-CN" altLang="en-US" smtClean="0"/>
              <a:pPr/>
              <a:t>2013-5-2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20CA16-1179-4101-BD36-80C39AD70DA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2374558" y="1453108"/>
          <a:ext cx="2160238" cy="5974080"/>
        </p:xfrm>
        <a:graphic>
          <a:graphicData uri="http://schemas.openxmlformats.org/drawingml/2006/table">
            <a:tbl>
              <a:tblPr/>
              <a:tblGrid>
                <a:gridCol w="272030"/>
                <a:gridCol w="236026"/>
                <a:gridCol w="236026"/>
                <a:gridCol w="236026"/>
                <a:gridCol w="236026"/>
                <a:gridCol w="236026"/>
                <a:gridCol w="236026"/>
                <a:gridCol w="236026"/>
                <a:gridCol w="236026"/>
              </a:tblGrid>
              <a:tr h="111686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1" u="none" strike="noStrike" dirty="0" smtClean="0">
                          <a:latin typeface="Arial" pitchFamily="34" charset="0"/>
                          <a:cs typeface="Arial" pitchFamily="34" charset="0"/>
                        </a:rPr>
                        <a:t>GmaPHO1; H2</a:t>
                      </a: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oot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tem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eave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lower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1</a:t>
                      </a:r>
                      <a:endParaRPr lang="zh-CN" altLang="en-US" sz="400" b="1" i="0" u="none" strike="noStrik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3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5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7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oot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tem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5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eave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21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56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lower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1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1</a:t>
                      </a:r>
                      <a:endParaRPr lang="zh-CN" altLang="en-US" sz="400" b="1" i="0" u="none" strike="noStrik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5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3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2448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2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5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2937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7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9785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7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4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1683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 dirty="0">
                          <a:latin typeface="Arial" pitchFamily="34" charset="0"/>
                          <a:cs typeface="Arial" pitchFamily="34" charset="0"/>
                        </a:rPr>
                        <a:t>0.0104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95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201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 dirty="0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1686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1" u="none" strike="noStrike" dirty="0" smtClean="0">
                          <a:latin typeface="Arial" pitchFamily="34" charset="0"/>
                          <a:cs typeface="Arial" pitchFamily="34" charset="0"/>
                        </a:rPr>
                        <a:t>GmaPHO1; H3</a:t>
                      </a: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oot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tem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eave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lower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1</a:t>
                      </a:r>
                      <a:endParaRPr lang="zh-CN" altLang="en-US" sz="400" b="1" i="0" u="none" strike="noStrik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3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5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7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oot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tem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eave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33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7731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lower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1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1</a:t>
                      </a:r>
                      <a:endParaRPr lang="zh-CN" altLang="en-US" sz="400" b="1" i="0" u="none" strike="noStrik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88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3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3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2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11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4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19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5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5613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2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7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5751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2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9978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 dirty="0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1686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1" u="none" strike="noStrike" dirty="0" smtClean="0">
                          <a:latin typeface="Arial" pitchFamily="34" charset="0"/>
                          <a:cs typeface="Arial" pitchFamily="34" charset="0"/>
                        </a:rPr>
                        <a:t>GmaPHO1; H6</a:t>
                      </a: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oot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tem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eave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lower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1</a:t>
                      </a:r>
                      <a:endParaRPr lang="zh-CN" altLang="en-US" sz="400" b="1" i="0" u="none" strike="noStrik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3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5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7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oot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tem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5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eave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6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lower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1</a:t>
                      </a:r>
                      <a:endParaRPr lang="zh-CN" altLang="en-US" sz="400" b="1" i="0" u="none" strike="noStrik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2605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2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3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23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32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5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12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37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7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4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1997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 dirty="0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1686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1" u="none" strike="noStrike" dirty="0" smtClean="0">
                          <a:latin typeface="Arial" pitchFamily="34" charset="0"/>
                          <a:cs typeface="Arial" pitchFamily="34" charset="0"/>
                        </a:rPr>
                        <a:t>GmaPHO1; H7</a:t>
                      </a: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oot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tem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eave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lower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1</a:t>
                      </a:r>
                      <a:endParaRPr lang="zh-CN" altLang="en-US" sz="400" b="1" i="0" u="none" strike="noStrik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3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5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7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oot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tem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eave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1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lower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15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258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1</a:t>
                      </a:r>
                      <a:endParaRPr lang="zh-CN" altLang="en-US" sz="400" b="1" i="0" u="none" strike="noStrik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22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5094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3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1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1273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1031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65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5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1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5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4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7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4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346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66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28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129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1412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 dirty="0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1686">
                <a:tc>
                  <a:txBody>
                    <a:bodyPr/>
                    <a:lstStyle/>
                    <a:p>
                      <a:pPr algn="ctr" fontAlgn="b"/>
                      <a:r>
                        <a:rPr lang="en-US" sz="400" b="1" i="1" u="none" strike="noStrike" dirty="0" smtClean="0">
                          <a:latin typeface="Arial" pitchFamily="34" charset="0"/>
                          <a:cs typeface="Arial" pitchFamily="34" charset="0"/>
                        </a:rPr>
                        <a:t>GmaPHO1; H9/H10</a:t>
                      </a: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oot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tem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eave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lower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1</a:t>
                      </a:r>
                      <a:endParaRPr lang="zh-CN" altLang="en-US" sz="400" b="1" i="0" u="none" strike="noStrik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3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5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7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oot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tem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6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eave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4177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lower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11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1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1</a:t>
                      </a:r>
                      <a:endParaRPr lang="zh-CN" altLang="en-US" sz="400" b="1" i="0" u="none" strike="noStrik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73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1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3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17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1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5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1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2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971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7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7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523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 dirty="0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1686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1" u="none" strike="noStrike" dirty="0" smtClean="0">
                          <a:latin typeface="Arial" pitchFamily="34" charset="0"/>
                          <a:cs typeface="Arial" pitchFamily="34" charset="0"/>
                        </a:rPr>
                        <a:t>GmaPHO1; H1/H4</a:t>
                      </a: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oot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tem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eave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lower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1</a:t>
                      </a:r>
                      <a:endParaRPr lang="zh-CN" altLang="en-US" sz="400" b="1" i="0" u="none" strike="noStrik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3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5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7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oot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tem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8434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eave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lower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1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1</a:t>
                      </a:r>
                      <a:endParaRPr lang="zh-CN" altLang="en-US" sz="400" b="1" i="0" u="none" strike="noStrik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123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3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141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623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5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35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1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7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121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6376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263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 dirty="0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1686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1" u="none" strike="noStrike" dirty="0" smtClean="0">
                          <a:latin typeface="Arial" pitchFamily="34" charset="0"/>
                          <a:cs typeface="Arial" pitchFamily="34" charset="0"/>
                        </a:rPr>
                        <a:t>GmaPHO1; H5</a:t>
                      </a: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oot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tem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eave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lower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1</a:t>
                      </a:r>
                      <a:endParaRPr lang="zh-CN" altLang="en-US" sz="400" b="1" i="0" u="none" strike="noStrik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3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5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7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oot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tem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eave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lower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371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1</a:t>
                      </a:r>
                      <a:endParaRPr lang="zh-CN" altLang="en-US" sz="400" b="1" i="0" u="none" strike="noStrik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191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3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27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817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5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6332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19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7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7378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4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58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717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 dirty="0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1686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1" u="none" strike="noStrike" dirty="0" smtClean="0">
                          <a:latin typeface="Arial" pitchFamily="34" charset="0"/>
                          <a:cs typeface="Arial" pitchFamily="34" charset="0"/>
                        </a:rPr>
                        <a:t>GmaPHO1; H8</a:t>
                      </a: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oot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tem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eave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lower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1</a:t>
                      </a:r>
                      <a:endParaRPr lang="zh-CN" altLang="en-US" sz="400" b="1" i="0" u="none" strike="noStrik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3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5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7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oot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tem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3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eave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2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lower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17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1</a:t>
                      </a:r>
                      <a:endParaRPr lang="zh-CN" altLang="en-US" sz="400" b="1" i="0" u="none" strike="noStrik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2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86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3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2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47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41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5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2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6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7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2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32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209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 dirty="0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1686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1" u="none" strike="noStrike" dirty="0" smtClean="0">
                          <a:latin typeface="Arial" pitchFamily="34" charset="0"/>
                          <a:cs typeface="Arial" pitchFamily="34" charset="0"/>
                        </a:rPr>
                        <a:t>GmaPHO1; H12/H14</a:t>
                      </a: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oot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tem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eave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lower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1</a:t>
                      </a:r>
                      <a:endParaRPr lang="zh-CN" altLang="en-US" sz="400" b="1" i="0" u="none" strike="noStrik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3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5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7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Root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Stem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6634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Leave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7117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8865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lowers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1.000 </a:t>
                      </a:r>
                      <a:endParaRPr lang="en-US" altLang="zh-CN" sz="400" b="0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1</a:t>
                      </a:r>
                      <a:endParaRPr lang="zh-CN" altLang="en-US" sz="400" b="1" i="0" u="none" strike="noStrike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19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2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2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 smtClean="0">
                          <a:latin typeface="Arial" pitchFamily="34" charset="0"/>
                          <a:cs typeface="Arial" pitchFamily="34" charset="0"/>
                        </a:rPr>
                        <a:t>0.000</a:t>
                      </a:r>
                      <a:endParaRPr lang="en-US" altLang="zh-CN" sz="400" b="0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3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11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1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1528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5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24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1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1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81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0.0003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400" b="0" i="0" u="none" strike="noStrike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55843"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1" i="0" u="none" strike="noStrike" dirty="0" smtClean="0">
                          <a:latin typeface="Arial" pitchFamily="34" charset="0"/>
                          <a:cs typeface="Arial" pitchFamily="34" charset="0"/>
                        </a:rPr>
                        <a:t>Fruits7</a:t>
                      </a:r>
                      <a:endParaRPr lang="zh-CN" altLang="en-US" sz="400" b="1" i="0" u="none" strike="noStrike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 dirty="0">
                          <a:latin typeface="Arial" pitchFamily="34" charset="0"/>
                          <a:cs typeface="Arial" pitchFamily="34" charset="0"/>
                        </a:rPr>
                        <a:t>0.0211 </a:t>
                      </a:r>
                    </a:p>
                  </a:txBody>
                  <a:tcPr marL="0" marR="0" marT="0" marB="0" anchor="ctr" anchorCtr="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 dirty="0">
                          <a:latin typeface="Arial" pitchFamily="34" charset="0"/>
                          <a:cs typeface="Arial" pitchFamily="34" charset="0"/>
                        </a:rPr>
                        <a:t>0.0019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 dirty="0">
                          <a:latin typeface="Arial" pitchFamily="34" charset="0"/>
                          <a:cs typeface="Arial" pitchFamily="34" charset="0"/>
                        </a:rPr>
                        <a:t>0.0011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 dirty="0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 dirty="0">
                          <a:latin typeface="Arial" pitchFamily="34" charset="0"/>
                          <a:cs typeface="Arial" pitchFamily="34" charset="0"/>
                        </a:rPr>
                        <a:t>0.0005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 dirty="0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 dirty="0">
                          <a:latin typeface="Arial" pitchFamily="34" charset="0"/>
                          <a:cs typeface="Arial" pitchFamily="34" charset="0"/>
                        </a:rPr>
                        <a:t>0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400" b="0" i="0" u="none" strike="noStrike" dirty="0">
                          <a:latin typeface="Arial" pitchFamily="34" charset="0"/>
                          <a:cs typeface="Arial" pitchFamily="34" charset="0"/>
                        </a:rPr>
                        <a:t>1.0000 </a:t>
                      </a:r>
                    </a:p>
                  </a:txBody>
                  <a:tcPr marL="0" marR="0" marT="0" marB="0" anchor="ctr" anchorCtr="1">
                    <a:lnL>
                      <a:noFill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  <p:sp>
        <p:nvSpPr>
          <p:cNvPr id="3" name="TextBox 4616"/>
          <p:cNvSpPr txBox="1"/>
          <p:nvPr/>
        </p:nvSpPr>
        <p:spPr>
          <a:xfrm>
            <a:off x="2113864" y="7667644"/>
            <a:ext cx="292895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dirty="0" smtClean="0">
                <a:latin typeface="Arial" pitchFamily="34" charset="0"/>
                <a:cs typeface="Arial" pitchFamily="34" charset="0"/>
              </a:rPr>
              <a:t>Figure S5.</a:t>
            </a:r>
            <a:r>
              <a:rPr lang="en-US" sz="1200" b="1" dirty="0" smtClean="0"/>
              <a:t> The reciprocal significance of gene expression variation among tissues.</a:t>
            </a:r>
            <a:endParaRPr lang="zh-CN" altLang="en-US" sz="1200" dirty="0"/>
          </a:p>
        </p:txBody>
      </p:sp>
      <p:sp>
        <p:nvSpPr>
          <p:cNvPr id="5" name="TextBox 4"/>
          <p:cNvSpPr txBox="1"/>
          <p:nvPr/>
        </p:nvSpPr>
        <p:spPr>
          <a:xfrm>
            <a:off x="2169292" y="1381100"/>
            <a:ext cx="2160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a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169292" y="2056175"/>
            <a:ext cx="2160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b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2169292" y="2731250"/>
            <a:ext cx="2160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c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169292" y="3406325"/>
            <a:ext cx="2160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d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2169292" y="4081400"/>
            <a:ext cx="2160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e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169292" y="4756475"/>
            <a:ext cx="2160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f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2169292" y="5431550"/>
            <a:ext cx="2160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g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169292" y="6106625"/>
            <a:ext cx="2160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smtClean="0">
                <a:latin typeface="Arial" pitchFamily="34" charset="0"/>
                <a:cs typeface="Arial" pitchFamily="34" charset="0"/>
              </a:rPr>
              <a:t>h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169292" y="6781700"/>
            <a:ext cx="21602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b="1" dirty="0" err="1" smtClean="0">
                <a:latin typeface="Arial" pitchFamily="34" charset="0"/>
                <a:cs typeface="Arial" pitchFamily="34" charset="0"/>
              </a:rPr>
              <a:t>i</a:t>
            </a:r>
            <a:endParaRPr lang="zh-CN" altLang="en-US" sz="10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0</TotalTime>
  <Words>517</Words>
  <Application>Microsoft Office PowerPoint</Application>
  <PresentationFormat>A4 纸张(210x297 毫米)</PresentationFormat>
  <Paragraphs>487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幻灯片 1</vt:lpstr>
    </vt:vector>
  </TitlesOfParts>
  <Company>zhongkeyuan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helingli</dc:creator>
  <cp:lastModifiedBy>unknown</cp:lastModifiedBy>
  <cp:revision>32</cp:revision>
  <dcterms:created xsi:type="dcterms:W3CDTF">2013-05-03T07:10:08Z</dcterms:created>
  <dcterms:modified xsi:type="dcterms:W3CDTF">2013-05-21T07:09:12Z</dcterms:modified>
</cp:coreProperties>
</file>